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9" r:id="rId2"/>
  </p:sldIdLst>
  <p:sldSz cx="12192000" cy="6858000"/>
  <p:notesSz cx="6858000" cy="9144000"/>
  <p:defaultTextStyle>
    <a:defPPr>
      <a:defRPr lang="en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46"/>
  </p:normalViewPr>
  <p:slideViewPr>
    <p:cSldViewPr snapToGrid="0">
      <p:cViewPr varScale="1">
        <p:scale>
          <a:sx n="115" d="100"/>
          <a:sy n="115" d="100"/>
        </p:scale>
        <p:origin x="4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7F0F6-22F2-9651-4712-C33F98B1D0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E788BD-84C9-CCD8-8FD6-21D92AA30E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CC9633-CD34-E8C8-1894-6E3151476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8BFE70-CC9B-8655-0C6F-3DB7AA4DB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6DC60-8C6E-A55D-32F5-34BFFAB4A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4041407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2B962-7045-1639-1A2A-C0D4FAC134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05139C-2B8D-2940-912A-74394FB998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EB6555-E91C-8A6E-5924-B8897DC4F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00F49E-AC17-1A42-63B5-6C8BC1E00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2A7896-3B7C-B067-3639-45532A61E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857253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3AE3AB-CD31-F8E8-C083-2A9882902B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459CBB-4570-33BB-95B9-7079CFA6D5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3CE37D-AC08-ABCD-CD49-892315E89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46180-1594-8281-BDF5-579159F61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6599D0-23C4-8521-9DC2-A9F73A07E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713898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C8E50-3C7F-37D8-4B97-1C944065C8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D656E5-4CAA-C325-F2D8-1A1364B1D6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6B2696-9A0E-D1CD-6957-DA05A34DE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AF984-6FE4-3192-25CD-EC380F36B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821EE-D0A1-14D3-38CB-540272A75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757085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B01A70-8498-680E-C965-37F70F9EB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EA0C7C-762D-C2D7-0C49-54A050C60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6E371E-EA6D-ABF3-AD96-97891E24D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A59E4-9D52-EB61-8295-860B96A8B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093AC6-7265-AA5C-5D26-0C7D5E658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163197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40EB2-3AA5-BE1D-603A-8D0E9B2E6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99892-8138-95C5-90A2-6AFDB24643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61248D-9618-9DE2-9581-77013DD772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2F6C51-2293-43CB-7820-F71DDEB55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A588D0-FC15-DB02-05E2-46EC08AE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24BC33-99CE-0C3F-6298-51C24FE49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381955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F91E5-F2A0-B5D9-23BC-727FE9161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B9D0D5-72CD-7C9A-443B-A8D8DC7587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2840D-1BA2-924D-D167-68453DCCAD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699D48-B7C4-E0DB-FB76-BA955A32CF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9E1E96-ECA1-DBF7-F99F-F6ADDC8BBF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83D71C-65FB-2CE9-B536-35C53474F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E7D392-45C9-BCEE-E533-DF0A95288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C44C21-779A-858C-B57A-2770C15BB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61371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14CB2-BFC4-B693-08AF-E84694E6C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0F8AAE-8391-1A5D-AE32-15990B3B7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CBF432-A5D8-81FD-AC30-2EAA0F33E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92B4FD-B9C6-04D3-A137-7B806D56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1339741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D85E243-5B73-0EAF-18BC-ACA27718A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A3370C-D0A7-A318-989C-1458378B7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88B71F-669E-F351-ECF0-2D4E129B9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69949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5A4D6-DA55-9C0D-58FD-996181552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D4BB8C-5C54-94FB-32ED-B694683D85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F7111B-0B43-3C67-613B-7FBDFD680C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C743AB-99D3-D54B-18A6-14B9E370E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B899DF-17D2-AFD7-FE59-07E7C5864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741659-A973-AE58-5062-CAD53943A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581313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A0FC6-550F-F074-06D2-832C348FF4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7A8B1A-F3EB-499C-6968-5D057DDFCC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6C081F-7784-5FAE-0E76-3F6573FEE8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90B984-D5A1-44D9-C89B-31AC0B517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944AE4-39D8-1517-576A-2DDEA7905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F2F7A6-0590-C58D-E5EF-A2A3FFA2D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2078127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532F62-F27D-2699-76F3-F0D040CC58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1414DD-B508-121B-E051-0133C11A1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8BE4C-70DF-4816-ECB1-3F01F49051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C280C-3533-0046-9E79-142E6A9115AE}" type="datetimeFigureOut">
              <a:rPr lang="en-GR" smtClean="0"/>
              <a:t>9/2/25</a:t>
            </a:fld>
            <a:endParaRPr lang="en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0EB93C-47B7-7A6C-0A88-6A27FB6726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7363E9-7FB6-C6F4-EE91-66BD97B752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51DA3-AAA0-C444-A9E2-E0E7E34CC2DC}" type="slidenum">
              <a:rPr lang="en-GR" smtClean="0"/>
              <a:t>‹#›</a:t>
            </a:fld>
            <a:endParaRPr lang="en-GR"/>
          </a:p>
        </p:txBody>
      </p:sp>
    </p:spTree>
    <p:extLst>
      <p:ext uri="{BB962C8B-B14F-4D97-AF65-F5344CB8AC3E}">
        <p14:creationId xmlns:p14="http://schemas.microsoft.com/office/powerpoint/2010/main" val="3594343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CBE1B56D-9F90-E9B0-E378-2A992DD469C3}"/>
              </a:ext>
            </a:extLst>
          </p:cNvPr>
          <p:cNvGraphicFramePr>
            <a:graphicFrameLocks noGrp="1"/>
          </p:cNvGraphicFramePr>
          <p:nvPr/>
        </p:nvGraphicFramePr>
        <p:xfrm>
          <a:off x="2247492" y="1213935"/>
          <a:ext cx="7285615" cy="3445612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797393">
                  <a:extLst>
                    <a:ext uri="{9D8B030D-6E8A-4147-A177-3AD203B41FA5}">
                      <a16:colId xmlns:a16="http://schemas.microsoft.com/office/drawing/2014/main" val="2339515962"/>
                    </a:ext>
                  </a:extLst>
                </a:gridCol>
                <a:gridCol w="1756231">
                  <a:extLst>
                    <a:ext uri="{9D8B030D-6E8A-4147-A177-3AD203B41FA5}">
                      <a16:colId xmlns:a16="http://schemas.microsoft.com/office/drawing/2014/main" val="2118257144"/>
                    </a:ext>
                  </a:extLst>
                </a:gridCol>
                <a:gridCol w="1289732">
                  <a:extLst>
                    <a:ext uri="{9D8B030D-6E8A-4147-A177-3AD203B41FA5}">
                      <a16:colId xmlns:a16="http://schemas.microsoft.com/office/drawing/2014/main" val="4221103266"/>
                    </a:ext>
                  </a:extLst>
                </a:gridCol>
                <a:gridCol w="2442259">
                  <a:extLst>
                    <a:ext uri="{9D8B030D-6E8A-4147-A177-3AD203B41FA5}">
                      <a16:colId xmlns:a16="http://schemas.microsoft.com/office/drawing/2014/main" val="2507778713"/>
                    </a:ext>
                  </a:extLst>
                </a:gridCol>
              </a:tblGrid>
              <a:tr h="3929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Cell Marker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Fluorophor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Clon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Manufacturer*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/>
                </a:tc>
                <a:extLst>
                  <a:ext uri="{0D108BD9-81ED-4DB2-BD59-A6C34878D82A}">
                    <a16:rowId xmlns:a16="http://schemas.microsoft.com/office/drawing/2014/main" val="3983015763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P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161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581740232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PC/Cy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SK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85918866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OXP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I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206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064937624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be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erCP/Cy5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O4-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773870237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OR</a:t>
                      </a:r>
                      <a:r>
                        <a:rPr lang="el-GR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γ</a:t>
                      </a: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Q21-5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87385412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279 (PD-1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rilliant Violet 4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H12.2H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126979565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LAD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P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L2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944108315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erCP/Cy5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63D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42590541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I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HI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284089696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E/Cy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3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05325270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PC/Cy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67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589767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274 (PD-L1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rilliant Violet 4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29E.2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81506767"/>
                  </a:ext>
                </a:extLst>
              </a:tr>
              <a:tr h="218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273 (PD-L2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IH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01059775"/>
                  </a:ext>
                </a:extLst>
              </a:tr>
              <a:tr h="218048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s-ES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*Biolegend (San Diego, CA, USA); BD </a:t>
                      </a:r>
                      <a:r>
                        <a:rPr lang="es-ES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sciences</a:t>
                      </a:r>
                      <a:r>
                        <a:rPr lang="es-ES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(San </a:t>
                      </a:r>
                      <a:r>
                        <a:rPr lang="es-ES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Jose</a:t>
                      </a:r>
                      <a:r>
                        <a:rPr lang="es-ES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, CA, USA); R&amp;D </a:t>
                      </a:r>
                      <a:r>
                        <a:rPr lang="es-ES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ystems</a:t>
                      </a:r>
                      <a:r>
                        <a:rPr lang="es-ES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(Minneapolis, MN, USA)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930826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2BD605B-10B5-AC40-0771-C716A9426C7E}"/>
              </a:ext>
            </a:extLst>
          </p:cNvPr>
          <p:cNvSpPr txBox="1"/>
          <p:nvPr/>
        </p:nvSpPr>
        <p:spPr>
          <a:xfrm>
            <a:off x="2247492" y="768735"/>
            <a:ext cx="7285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. Table 1. Summary of antibodies’ information used in Flow Cytometry</a:t>
            </a:r>
          </a:p>
        </p:txBody>
      </p:sp>
    </p:spTree>
    <p:extLst>
      <p:ext uri="{BB962C8B-B14F-4D97-AF65-F5344CB8AC3E}">
        <p14:creationId xmlns:p14="http://schemas.microsoft.com/office/powerpoint/2010/main" val="1798859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2</Words>
  <Application>Microsoft Macintosh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5-02-09T06:38:25Z</dcterms:created>
  <dcterms:modified xsi:type="dcterms:W3CDTF">2025-02-09T06:43:02Z</dcterms:modified>
</cp:coreProperties>
</file>